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2.png" ContentType="image/png"/>
  <Override PartName="/ppt/media/image10.png" ContentType="image/png"/>
  <Override PartName="/ppt/media/image6.jpeg" ContentType="image/jpeg"/>
  <Override PartName="/ppt/media/image9.png" ContentType="image/png"/>
  <Override PartName="/ppt/media/image8.jpeg" ContentType="image/jpeg"/>
  <Override PartName="/ppt/media/image17.png" ContentType="image/png"/>
  <Override PartName="/ppt/media/image16.png" ContentType="image/png"/>
  <Override PartName="/ppt/media/image15.png" ContentType="image/png"/>
  <Override PartName="/ppt/media/image5.jpeg" ContentType="image/jpeg"/>
  <Override PartName="/ppt/media/image14.png" ContentType="image/png"/>
  <Override PartName="/ppt/media/image1.png" ContentType="image/png"/>
  <Override PartName="/ppt/media/image3.png" ContentType="image/png"/>
  <Override PartName="/ppt/media/image4.jpeg" ContentType="image/jpeg"/>
  <Override PartName="/ppt/media/image2.png" ContentType="image/png"/>
  <Override PartName="/ppt/media/image13.png" ContentType="image/png"/>
  <Override PartName="/ppt/media/image18.png" ContentType="image/png"/>
  <Override PartName="/ppt/media/image7.jpeg" ContentType="image/jpeg"/>
  <Override PartName="/ppt/media/image1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16348075" cy="284622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579132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1076544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81720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579132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1076544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1225440" y="4367160"/>
            <a:ext cx="13893840" cy="1396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579132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10765440" y="665964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/>
          </p:nvPr>
        </p:nvSpPr>
        <p:spPr>
          <a:xfrm>
            <a:off x="81720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/>
          </p:nvPr>
        </p:nvSpPr>
        <p:spPr>
          <a:xfrm>
            <a:off x="579132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/>
          </p:nvPr>
        </p:nvSpPr>
        <p:spPr>
          <a:xfrm>
            <a:off x="10765440" y="15282360"/>
            <a:ext cx="473688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1225440" y="4367160"/>
            <a:ext cx="13893840" cy="1396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8355600" y="1528236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8172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8355600" y="6659640"/>
            <a:ext cx="717912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817200" y="15282360"/>
            <a:ext cx="14711400" cy="78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6.xml"/><Relationship Id="rId8" Type="http://schemas.openxmlformats.org/officeDocument/2006/relationships/slideLayout" Target="../slideLayouts/slideLayout17.xml"/><Relationship Id="rId9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1.xml"/><Relationship Id="rId13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3.xml"/><Relationship Id="rId15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1f497d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" descr=""/>
          <p:cNvPicPr/>
          <p:nvPr/>
        </p:nvPicPr>
        <p:blipFill>
          <a:blip r:embed="rId2"/>
          <a:stretch/>
        </p:blipFill>
        <p:spPr>
          <a:xfrm>
            <a:off x="817560" y="9043920"/>
            <a:ext cx="14711400" cy="11739600"/>
          </a:xfrm>
          <a:prstGeom prst="rect">
            <a:avLst/>
          </a:prstGeom>
          <a:ln w="0">
            <a:noFill/>
          </a:ln>
        </p:spPr>
      </p:pic>
      <p:pic>
        <p:nvPicPr>
          <p:cNvPr id="39" name="Picture 4" descr=""/>
          <p:cNvPicPr/>
          <p:nvPr/>
        </p:nvPicPr>
        <p:blipFill>
          <a:blip r:embed="rId3"/>
          <a:stretch/>
        </p:blipFill>
        <p:spPr>
          <a:xfrm>
            <a:off x="817560" y="9043920"/>
            <a:ext cx="14711400" cy="11739600"/>
          </a:xfrm>
          <a:prstGeom prst="rect">
            <a:avLst/>
          </a:prstGeom>
          <a:ln w="0">
            <a:noFill/>
          </a:ln>
        </p:spPr>
      </p:pic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1225440" y="4367160"/>
            <a:ext cx="13893840" cy="301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1f497d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1f497d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body"/>
          </p:nvPr>
        </p:nvSpPr>
        <p:spPr>
          <a:xfrm>
            <a:off x="817200" y="6659640"/>
            <a:ext cx="14711400" cy="1650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  <p:sldLayoutId id="2147483672" r:id="rId14"/>
    <p:sldLayoutId id="2147483673" r:id="rId15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jpeg"/><Relationship Id="rId4" Type="http://schemas.openxmlformats.org/officeDocument/2006/relationships/image" Target="../media/image5.jpeg"/><Relationship Id="rId5" Type="http://schemas.openxmlformats.org/officeDocument/2006/relationships/image" Target="../media/image6.jpeg"/><Relationship Id="rId6" Type="http://schemas.openxmlformats.org/officeDocument/2006/relationships/image" Target="../media/image7.jpeg"/><Relationship Id="rId7" Type="http://schemas.openxmlformats.org/officeDocument/2006/relationships/image" Target="../media/image8.jpe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2" descr=""/>
          <p:cNvPicPr/>
          <p:nvPr/>
        </p:nvPicPr>
        <p:blipFill>
          <a:blip r:embed="rId1"/>
          <a:srcRect l="4774" t="0" r="0" b="0"/>
          <a:stretch/>
        </p:blipFill>
        <p:spPr>
          <a:xfrm>
            <a:off x="95400" y="4383000"/>
            <a:ext cx="3620880" cy="309096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3" descr=""/>
          <p:cNvPicPr/>
          <p:nvPr/>
        </p:nvPicPr>
        <p:blipFill>
          <a:blip r:embed="rId2"/>
          <a:stretch/>
        </p:blipFill>
        <p:spPr>
          <a:xfrm>
            <a:off x="7945560" y="4383000"/>
            <a:ext cx="4471920" cy="3103560"/>
          </a:xfrm>
          <a:prstGeom prst="rect">
            <a:avLst/>
          </a:prstGeom>
          <a:ln w="0">
            <a:noFill/>
          </a:ln>
        </p:spPr>
      </p:pic>
      <p:sp>
        <p:nvSpPr>
          <p:cNvPr id="80" name="Rectangle 1"/>
          <p:cNvSpPr/>
          <p:nvPr/>
        </p:nvSpPr>
        <p:spPr>
          <a:xfrm>
            <a:off x="0" y="8412120"/>
            <a:ext cx="16212960" cy="435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ig. S3.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OPK depletion causes increased apoptosis. (A) Immunoblotting to assess the effect of 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OPK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knockdown on the expression of cyclin B1 and cyclin E1</a:t>
            </a: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Vinculin was used as a loading control.</a:t>
            </a: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(B) Immunoblotting to assess the effect of 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OPK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knockdown on the phosphorylation of Akt. Vinculin was used as a loading control. (C) Flow cytometric analysis of 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OPK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knockdown cells at 24, 48, and 72 hours post-IR using PI vs Annexin V staining. The apoptotic population is shown in red. Numbers represent percentage of apoptotic cells. Quantification in Table S3. (D) Hoechst assay looking at apoptosis using two different siRNAs si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OPK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_2 and si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OPK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_3. (E) Alkaline COMET assay at 0 hours, 0.5 hours, 2 hours and 8 hours. (F) Number of γ-H2AX foci per cell at 0 hours, 0.5 hours, 2 hours, 4 hours, 8 hours and 24 hours following irradiation. Results were analysed using an unpaired two-sided student's t-test, *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&lt;0.05.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CustomShape 1"/>
          <p:cNvSpPr/>
          <p:nvPr/>
        </p:nvSpPr>
        <p:spPr>
          <a:xfrm>
            <a:off x="84240" y="30240"/>
            <a:ext cx="430200" cy="66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2" name="Group 2"/>
          <p:cNvGrpSpPr/>
          <p:nvPr/>
        </p:nvGrpSpPr>
        <p:grpSpPr>
          <a:xfrm>
            <a:off x="19080" y="166680"/>
            <a:ext cx="6418080" cy="3278160"/>
            <a:chOff x="19080" y="166680"/>
            <a:chExt cx="6418080" cy="3278160"/>
          </a:xfrm>
        </p:grpSpPr>
        <p:sp>
          <p:nvSpPr>
            <p:cNvPr id="83" name="Line 153"/>
            <p:cNvSpPr/>
            <p:nvPr/>
          </p:nvSpPr>
          <p:spPr>
            <a:xfrm>
              <a:off x="1739160" y="635040"/>
              <a:ext cx="4598640" cy="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CustomShape 127"/>
            <p:cNvSpPr/>
            <p:nvPr/>
          </p:nvSpPr>
          <p:spPr>
            <a:xfrm>
              <a:off x="742680" y="3030120"/>
              <a:ext cx="84600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  <a:ea typeface="Droid Sans Fallback"/>
                </a:rPr>
                <a:t>Vinculin ►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132"/>
            <p:cNvSpPr/>
            <p:nvPr/>
          </p:nvSpPr>
          <p:spPr>
            <a:xfrm>
              <a:off x="4190760" y="1035360"/>
              <a:ext cx="2215440" cy="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CustomShape 133"/>
            <p:cNvSpPr/>
            <p:nvPr/>
          </p:nvSpPr>
          <p:spPr>
            <a:xfrm>
              <a:off x="4269240" y="702720"/>
              <a:ext cx="205776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siTOPK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CustomShape 134"/>
            <p:cNvSpPr/>
            <p:nvPr/>
          </p:nvSpPr>
          <p:spPr>
            <a:xfrm>
              <a:off x="19080" y="962640"/>
              <a:ext cx="1326600" cy="30348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Time post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4 Gy IR (h) ►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CustomShape 135"/>
            <p:cNvSpPr/>
            <p:nvPr/>
          </p:nvSpPr>
          <p:spPr>
            <a:xfrm rot="7800">
              <a:off x="1801080" y="1267560"/>
              <a:ext cx="9144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CustomShape 136"/>
            <p:cNvSpPr/>
            <p:nvPr/>
          </p:nvSpPr>
          <p:spPr>
            <a:xfrm rot="7800">
              <a:off x="2144880" y="1267560"/>
              <a:ext cx="9144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CustomShape 137"/>
            <p:cNvSpPr/>
            <p:nvPr/>
          </p:nvSpPr>
          <p:spPr>
            <a:xfrm rot="7800">
              <a:off x="2449080" y="1267560"/>
              <a:ext cx="9144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CustomShape 138"/>
            <p:cNvSpPr/>
            <p:nvPr/>
          </p:nvSpPr>
          <p:spPr>
            <a:xfrm flipH="1" rot="8400">
              <a:off x="2734200" y="1267200"/>
              <a:ext cx="9144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CustomShape 139"/>
            <p:cNvSpPr/>
            <p:nvPr/>
          </p:nvSpPr>
          <p:spPr>
            <a:xfrm flipH="1" rot="8400">
              <a:off x="3038760" y="1267200"/>
              <a:ext cx="9144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CustomShape 140"/>
            <p:cNvSpPr/>
            <p:nvPr/>
          </p:nvSpPr>
          <p:spPr>
            <a:xfrm rot="7800">
              <a:off x="3316680" y="1266480"/>
              <a:ext cx="18252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CustomShape 141"/>
            <p:cNvSpPr/>
            <p:nvPr/>
          </p:nvSpPr>
          <p:spPr>
            <a:xfrm rot="7800">
              <a:off x="3621240" y="1266480"/>
              <a:ext cx="18252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CustomShape 142"/>
            <p:cNvSpPr/>
            <p:nvPr/>
          </p:nvSpPr>
          <p:spPr>
            <a:xfrm>
              <a:off x="629280" y="2430360"/>
              <a:ext cx="95940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Cyclin B1 ►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CustomShape 143"/>
            <p:cNvSpPr/>
            <p:nvPr/>
          </p:nvSpPr>
          <p:spPr>
            <a:xfrm>
              <a:off x="639000" y="1839240"/>
              <a:ext cx="94968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Cyclin</a:t>
              </a:r>
              <a:r>
                <a:rPr b="0" lang="it-IT" sz="2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E1</a:t>
              </a:r>
              <a:r>
                <a:rPr b="0" lang="it-IT" sz="2000" spc="-1" strike="noStrike">
                  <a:solidFill>
                    <a:srgbClr val="000000"/>
                  </a:solidFill>
                  <a:latin typeface="Arial"/>
                </a:rPr>
                <a:t> ►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144"/>
            <p:cNvSpPr/>
            <p:nvPr/>
          </p:nvSpPr>
          <p:spPr>
            <a:xfrm>
              <a:off x="1751400" y="1035000"/>
              <a:ext cx="2215080" cy="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CustomShape 145"/>
            <p:cNvSpPr/>
            <p:nvPr/>
          </p:nvSpPr>
          <p:spPr>
            <a:xfrm>
              <a:off x="1829880" y="702000"/>
              <a:ext cx="205776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siNT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CustomShape 146"/>
            <p:cNvSpPr/>
            <p:nvPr/>
          </p:nvSpPr>
          <p:spPr>
            <a:xfrm rot="7800">
              <a:off x="4282200" y="1267560"/>
              <a:ext cx="9144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CustomShape 147"/>
            <p:cNvSpPr/>
            <p:nvPr/>
          </p:nvSpPr>
          <p:spPr>
            <a:xfrm rot="7800">
              <a:off x="4586760" y="1267560"/>
              <a:ext cx="9144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CustomShape 148"/>
            <p:cNvSpPr/>
            <p:nvPr/>
          </p:nvSpPr>
          <p:spPr>
            <a:xfrm rot="7800">
              <a:off x="4891320" y="1267560"/>
              <a:ext cx="9144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CustomShape 149"/>
            <p:cNvSpPr/>
            <p:nvPr/>
          </p:nvSpPr>
          <p:spPr>
            <a:xfrm flipH="1" rot="8400">
              <a:off x="5176080" y="1267200"/>
              <a:ext cx="9144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CustomShape 150"/>
            <p:cNvSpPr/>
            <p:nvPr/>
          </p:nvSpPr>
          <p:spPr>
            <a:xfrm flipH="1" rot="8400">
              <a:off x="5481000" y="1267200"/>
              <a:ext cx="9144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CustomShape 151"/>
            <p:cNvSpPr/>
            <p:nvPr/>
          </p:nvSpPr>
          <p:spPr>
            <a:xfrm rot="7800">
              <a:off x="5758560" y="1266480"/>
              <a:ext cx="18252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CustomShape 152"/>
            <p:cNvSpPr/>
            <p:nvPr/>
          </p:nvSpPr>
          <p:spPr>
            <a:xfrm rot="7800">
              <a:off x="6063480" y="1266480"/>
              <a:ext cx="182520" cy="30744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CustomShape 154"/>
            <p:cNvSpPr/>
            <p:nvPr/>
          </p:nvSpPr>
          <p:spPr>
            <a:xfrm>
              <a:off x="1739160" y="166680"/>
              <a:ext cx="4698000" cy="34308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r>
                <a:rPr b="1" lang="it-IT" sz="2000" spc="-1" strike="noStrike" baseline="-33000">
                  <a:solidFill>
                    <a:srgbClr val="000000"/>
                  </a:solidFill>
                  <a:latin typeface="Arial"/>
                </a:rPr>
                <a:t>1</a:t>
              </a: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 synchronous cells released at T = 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7" name="Picture 69" descr=""/>
            <p:cNvPicPr/>
            <p:nvPr/>
          </p:nvPicPr>
          <p:blipFill>
            <a:blip r:embed="rId3"/>
            <a:srcRect l="9879" t="0" r="12740" b="0"/>
            <a:stretch/>
          </p:blipFill>
          <p:spPr>
            <a:xfrm>
              <a:off x="1595520" y="2323080"/>
              <a:ext cx="2384280" cy="52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08" name="Picture 70" descr=""/>
            <p:cNvPicPr/>
            <p:nvPr/>
          </p:nvPicPr>
          <p:blipFill>
            <a:blip r:embed="rId4"/>
            <a:srcRect l="8245" t="0" r="12170" b="0"/>
            <a:stretch/>
          </p:blipFill>
          <p:spPr>
            <a:xfrm>
              <a:off x="4043160" y="2323080"/>
              <a:ext cx="2394000" cy="52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09" name="Picture 71" descr=""/>
            <p:cNvPicPr/>
            <p:nvPr/>
          </p:nvPicPr>
          <p:blipFill>
            <a:blip r:embed="rId5"/>
            <a:srcRect l="8715" t="0" r="7482" b="0"/>
            <a:stretch/>
          </p:blipFill>
          <p:spPr>
            <a:xfrm>
              <a:off x="1595520" y="1731960"/>
              <a:ext cx="2384280" cy="52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10" name="Picture 72" descr=""/>
            <p:cNvPicPr/>
            <p:nvPr/>
          </p:nvPicPr>
          <p:blipFill>
            <a:blip r:embed="rId6"/>
            <a:srcRect l="5881" t="0" r="10019" b="0"/>
            <a:stretch/>
          </p:blipFill>
          <p:spPr>
            <a:xfrm>
              <a:off x="4043160" y="1731960"/>
              <a:ext cx="2394000" cy="52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11" name="Picture 73" descr=""/>
            <p:cNvPicPr/>
            <p:nvPr/>
          </p:nvPicPr>
          <p:blipFill>
            <a:blip r:embed="rId7"/>
            <a:srcRect l="4376" t="0" r="51471" b="0"/>
            <a:stretch/>
          </p:blipFill>
          <p:spPr>
            <a:xfrm>
              <a:off x="1595520" y="2922840"/>
              <a:ext cx="2384280" cy="52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12" name="Picture 74" descr=""/>
            <p:cNvPicPr/>
            <p:nvPr/>
          </p:nvPicPr>
          <p:blipFill>
            <a:blip r:embed="rId8"/>
            <a:srcRect l="51691" t="0" r="3975" b="0"/>
            <a:stretch/>
          </p:blipFill>
          <p:spPr>
            <a:xfrm>
              <a:off x="4043160" y="2922840"/>
              <a:ext cx="2394000" cy="52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sp>
        <p:nvSpPr>
          <p:cNvPr id="113" name="CustomShape 2"/>
          <p:cNvSpPr/>
          <p:nvPr/>
        </p:nvSpPr>
        <p:spPr>
          <a:xfrm>
            <a:off x="6969240" y="30240"/>
            <a:ext cx="428400" cy="66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4" name="Group 15"/>
          <p:cNvGrpSpPr/>
          <p:nvPr/>
        </p:nvGrpSpPr>
        <p:grpSpPr>
          <a:xfrm>
            <a:off x="11391840" y="166680"/>
            <a:ext cx="5086440" cy="6226200"/>
            <a:chOff x="11391840" y="166680"/>
            <a:chExt cx="5086440" cy="6226200"/>
          </a:xfrm>
        </p:grpSpPr>
        <p:sp>
          <p:nvSpPr>
            <p:cNvPr id="115" name="CustomShape 14"/>
            <p:cNvSpPr/>
            <p:nvPr/>
          </p:nvSpPr>
          <p:spPr>
            <a:xfrm>
              <a:off x="12707280" y="5908320"/>
              <a:ext cx="3358080" cy="484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DNA content (PI)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CustomShape 17"/>
            <p:cNvSpPr/>
            <p:nvPr/>
          </p:nvSpPr>
          <p:spPr>
            <a:xfrm>
              <a:off x="11391840" y="626760"/>
              <a:ext cx="1485360" cy="463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Time post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4Gy IR (h)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CustomShape 21"/>
            <p:cNvSpPr/>
            <p:nvPr/>
          </p:nvSpPr>
          <p:spPr>
            <a:xfrm rot="16200000">
              <a:off x="14673240" y="3058560"/>
              <a:ext cx="3133800" cy="476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Annexin V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8" name="Group 4"/>
            <p:cNvGrpSpPr/>
            <p:nvPr/>
          </p:nvGrpSpPr>
          <p:grpSpPr>
            <a:xfrm>
              <a:off x="12728880" y="646560"/>
              <a:ext cx="1658520" cy="1681560"/>
              <a:chOff x="12728880" y="646560"/>
              <a:chExt cx="1658520" cy="1681560"/>
            </a:xfrm>
          </p:grpSpPr>
          <p:pic>
            <p:nvPicPr>
              <p:cNvPr id="119" name="Picture 5" descr=""/>
              <p:cNvPicPr/>
              <p:nvPr/>
            </p:nvPicPr>
            <p:blipFill>
              <a:blip r:embed="rId9"/>
              <a:srcRect l="14607" t="10601" r="8296" b="11338"/>
              <a:stretch/>
            </p:blipFill>
            <p:spPr>
              <a:xfrm>
                <a:off x="12728880" y="646560"/>
                <a:ext cx="1597680" cy="16815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20" name="CustomShape 29"/>
              <p:cNvSpPr/>
              <p:nvPr/>
            </p:nvSpPr>
            <p:spPr>
              <a:xfrm flipH="1">
                <a:off x="13841640" y="1978920"/>
                <a:ext cx="545760" cy="342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04760" rIns="104760" tIns="52560" bIns="5256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1" name="Group 5"/>
            <p:cNvGrpSpPr/>
            <p:nvPr/>
          </p:nvGrpSpPr>
          <p:grpSpPr>
            <a:xfrm>
              <a:off x="12728880" y="2463840"/>
              <a:ext cx="1716840" cy="1681560"/>
              <a:chOff x="12728880" y="2463840"/>
              <a:chExt cx="1716840" cy="1681560"/>
            </a:xfrm>
          </p:grpSpPr>
          <p:pic>
            <p:nvPicPr>
              <p:cNvPr id="122" name="Picture 9" descr=""/>
              <p:cNvPicPr/>
              <p:nvPr/>
            </p:nvPicPr>
            <p:blipFill>
              <a:blip r:embed="rId10"/>
              <a:srcRect l="11451" t="10601" r="11451" b="11338"/>
              <a:stretch/>
            </p:blipFill>
            <p:spPr>
              <a:xfrm>
                <a:off x="12728880" y="2463840"/>
                <a:ext cx="1597320" cy="16815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23" name="CustomShape 30"/>
              <p:cNvSpPr/>
              <p:nvPr/>
            </p:nvSpPr>
            <p:spPr>
              <a:xfrm flipH="1">
                <a:off x="13899960" y="3796560"/>
                <a:ext cx="545760" cy="342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04760" rIns="104760" tIns="52560" bIns="5256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4" name="Group 6"/>
            <p:cNvGrpSpPr/>
            <p:nvPr/>
          </p:nvGrpSpPr>
          <p:grpSpPr>
            <a:xfrm>
              <a:off x="12728880" y="4251600"/>
              <a:ext cx="1768680" cy="1681560"/>
              <a:chOff x="12728880" y="4251600"/>
              <a:chExt cx="1768680" cy="1681560"/>
            </a:xfrm>
          </p:grpSpPr>
          <p:pic>
            <p:nvPicPr>
              <p:cNvPr id="125" name="Picture 8" descr=""/>
              <p:cNvPicPr/>
              <p:nvPr/>
            </p:nvPicPr>
            <p:blipFill>
              <a:blip r:embed="rId11"/>
              <a:srcRect l="11451" t="10601" r="11451" b="11338"/>
              <a:stretch/>
            </p:blipFill>
            <p:spPr>
              <a:xfrm>
                <a:off x="12728880" y="4251600"/>
                <a:ext cx="1597680" cy="16815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26" name="CustomShape 31"/>
              <p:cNvSpPr/>
              <p:nvPr/>
            </p:nvSpPr>
            <p:spPr>
              <a:xfrm flipH="1">
                <a:off x="13835880" y="5584320"/>
                <a:ext cx="661680" cy="342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04760" rIns="104760" tIns="52560" bIns="5256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</a:rPr>
                  <a:t>17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7" name="Group 9"/>
            <p:cNvGrpSpPr/>
            <p:nvPr/>
          </p:nvGrpSpPr>
          <p:grpSpPr>
            <a:xfrm>
              <a:off x="14440320" y="641880"/>
              <a:ext cx="1648800" cy="1690920"/>
              <a:chOff x="14440320" y="641880"/>
              <a:chExt cx="1648800" cy="1690920"/>
            </a:xfrm>
          </p:grpSpPr>
          <p:pic>
            <p:nvPicPr>
              <p:cNvPr id="128" name="Picture 4" descr=""/>
              <p:cNvPicPr/>
              <p:nvPr/>
            </p:nvPicPr>
            <p:blipFill>
              <a:blip r:embed="rId12"/>
              <a:srcRect l="14607" t="10979" r="8296" b="10979"/>
              <a:stretch/>
            </p:blipFill>
            <p:spPr>
              <a:xfrm>
                <a:off x="14440320" y="641880"/>
                <a:ext cx="1597680" cy="16819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29" name="CustomShape 35"/>
              <p:cNvSpPr/>
              <p:nvPr/>
            </p:nvSpPr>
            <p:spPr>
              <a:xfrm flipH="1">
                <a:off x="15427440" y="1990080"/>
                <a:ext cx="661680" cy="342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04760" rIns="104760" tIns="52560" bIns="5256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0" name="Group 8"/>
            <p:cNvGrpSpPr/>
            <p:nvPr/>
          </p:nvGrpSpPr>
          <p:grpSpPr>
            <a:xfrm>
              <a:off x="14440320" y="2459160"/>
              <a:ext cx="1750680" cy="1690920"/>
              <a:chOff x="14440320" y="2459160"/>
              <a:chExt cx="1750680" cy="1690920"/>
            </a:xfrm>
          </p:grpSpPr>
          <p:pic>
            <p:nvPicPr>
              <p:cNvPr id="131" name="Picture 3" descr=""/>
              <p:cNvPicPr/>
              <p:nvPr/>
            </p:nvPicPr>
            <p:blipFill>
              <a:blip r:embed="rId13"/>
              <a:srcRect l="11451" t="10979" r="11451" b="10979"/>
              <a:stretch/>
            </p:blipFill>
            <p:spPr>
              <a:xfrm>
                <a:off x="14440320" y="2459160"/>
                <a:ext cx="1597680" cy="16819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32" name="CustomShape 36"/>
              <p:cNvSpPr/>
              <p:nvPr/>
            </p:nvSpPr>
            <p:spPr>
              <a:xfrm flipH="1">
                <a:off x="15529320" y="3807360"/>
                <a:ext cx="661680" cy="342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04760" rIns="104760" tIns="52560" bIns="5256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</a:rPr>
                  <a:t>14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3" name="Group 7"/>
            <p:cNvGrpSpPr/>
            <p:nvPr/>
          </p:nvGrpSpPr>
          <p:grpSpPr>
            <a:xfrm>
              <a:off x="14440320" y="4251600"/>
              <a:ext cx="1745280" cy="1681560"/>
              <a:chOff x="14440320" y="4251600"/>
              <a:chExt cx="1745280" cy="1681560"/>
            </a:xfrm>
          </p:grpSpPr>
          <p:pic>
            <p:nvPicPr>
              <p:cNvPr id="134" name="Picture 2" descr=""/>
              <p:cNvPicPr/>
              <p:nvPr/>
            </p:nvPicPr>
            <p:blipFill>
              <a:blip r:embed="rId14"/>
              <a:srcRect l="11451" t="10979" r="11451" b="10979"/>
              <a:stretch/>
            </p:blipFill>
            <p:spPr>
              <a:xfrm>
                <a:off x="14440320" y="4251600"/>
                <a:ext cx="1597680" cy="16815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35" name="CustomShape 37"/>
              <p:cNvSpPr/>
              <p:nvPr/>
            </p:nvSpPr>
            <p:spPr>
              <a:xfrm flipH="1">
                <a:off x="15523920" y="5585040"/>
                <a:ext cx="661680" cy="342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04760" rIns="104760" tIns="52560" bIns="5256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</a:rPr>
                  <a:t>25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6" name="CustomShape 38"/>
            <p:cNvSpPr/>
            <p:nvPr/>
          </p:nvSpPr>
          <p:spPr>
            <a:xfrm flipH="1">
              <a:off x="11903400" y="1255680"/>
              <a:ext cx="896400" cy="463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24 </a:t>
              </a:r>
              <a:r>
                <a:rPr b="1" lang="it-IT" sz="2400" spc="-1" strike="noStrike">
                  <a:solidFill>
                    <a:srgbClr val="000000"/>
                  </a:solidFill>
                  <a:latin typeface="Arial"/>
                </a:rPr>
                <a:t>►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CustomShape 39"/>
            <p:cNvSpPr/>
            <p:nvPr/>
          </p:nvSpPr>
          <p:spPr>
            <a:xfrm flipH="1">
              <a:off x="11903400" y="4860360"/>
              <a:ext cx="896400" cy="463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72</a:t>
              </a:r>
              <a:r>
                <a:rPr b="1" lang="it-IT" sz="2400" spc="-1" strike="noStrike">
                  <a:solidFill>
                    <a:srgbClr val="000000"/>
                  </a:solidFill>
                  <a:latin typeface="Arial"/>
                </a:rPr>
                <a:t> ►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CustomShape 40"/>
            <p:cNvSpPr/>
            <p:nvPr/>
          </p:nvSpPr>
          <p:spPr>
            <a:xfrm flipH="1">
              <a:off x="11867040" y="3072960"/>
              <a:ext cx="914760" cy="463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48</a:t>
              </a:r>
              <a:r>
                <a:rPr b="1" lang="it-IT" sz="2400" spc="-1" strike="noStrike">
                  <a:solidFill>
                    <a:srgbClr val="000000"/>
                  </a:solidFill>
                  <a:latin typeface="Arial"/>
                </a:rPr>
                <a:t> ►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CustomShape 14"/>
            <p:cNvSpPr/>
            <p:nvPr/>
          </p:nvSpPr>
          <p:spPr>
            <a:xfrm>
              <a:off x="12786840" y="166680"/>
              <a:ext cx="1542960" cy="484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siNT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CustomShape 14"/>
            <p:cNvSpPr/>
            <p:nvPr/>
          </p:nvSpPr>
          <p:spPr>
            <a:xfrm>
              <a:off x="14493240" y="166680"/>
              <a:ext cx="1542960" cy="484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4760" rIns="104760" tIns="52560" bIns="5256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siTOPK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41" name="Picture 2" descr=""/>
          <p:cNvPicPr/>
          <p:nvPr/>
        </p:nvPicPr>
        <p:blipFill>
          <a:blip r:embed="rId15"/>
          <a:srcRect l="3500" t="0" r="4122" b="0"/>
          <a:stretch/>
        </p:blipFill>
        <p:spPr>
          <a:xfrm>
            <a:off x="3943440" y="4148280"/>
            <a:ext cx="3960720" cy="3325680"/>
          </a:xfrm>
          <a:prstGeom prst="rect">
            <a:avLst/>
          </a:prstGeom>
          <a:ln w="0">
            <a:noFill/>
          </a:ln>
        </p:spPr>
      </p:pic>
      <p:sp>
        <p:nvSpPr>
          <p:cNvPr id="142" name="CustomShape 2"/>
          <p:cNvSpPr/>
          <p:nvPr/>
        </p:nvSpPr>
        <p:spPr>
          <a:xfrm>
            <a:off x="84240" y="3798720"/>
            <a:ext cx="430200" cy="66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CustomShape 2"/>
          <p:cNvSpPr/>
          <p:nvPr/>
        </p:nvSpPr>
        <p:spPr>
          <a:xfrm>
            <a:off x="11880720" y="30240"/>
            <a:ext cx="428760" cy="66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4" name="Group 14"/>
          <p:cNvGrpSpPr/>
          <p:nvPr/>
        </p:nvGrpSpPr>
        <p:grpSpPr>
          <a:xfrm>
            <a:off x="5919840" y="644400"/>
            <a:ext cx="5472000" cy="2800440"/>
            <a:chOff x="5919840" y="644400"/>
            <a:chExt cx="5472000" cy="2800440"/>
          </a:xfrm>
        </p:grpSpPr>
        <p:pic>
          <p:nvPicPr>
            <p:cNvPr id="145" name="Picture 84" descr="Screen Clipping"/>
            <p:cNvPicPr/>
            <p:nvPr/>
          </p:nvPicPr>
          <p:blipFill>
            <a:blip r:embed="rId16"/>
            <a:srcRect l="0" t="6499" r="0" b="0"/>
            <a:stretch/>
          </p:blipFill>
          <p:spPr>
            <a:xfrm>
              <a:off x="7781040" y="2928600"/>
              <a:ext cx="3254400" cy="5162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46" name="Picture 85" descr="Screen Clipping"/>
            <p:cNvPicPr/>
            <p:nvPr/>
          </p:nvPicPr>
          <p:blipFill>
            <a:blip r:embed="rId17"/>
            <a:srcRect l="1163" t="9478" r="10174" b="10543"/>
            <a:stretch/>
          </p:blipFill>
          <p:spPr>
            <a:xfrm>
              <a:off x="7781040" y="1743480"/>
              <a:ext cx="3254400" cy="5162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47" name="TextBox 88"/>
            <p:cNvSpPr/>
            <p:nvPr/>
          </p:nvSpPr>
          <p:spPr>
            <a:xfrm>
              <a:off x="7884360" y="1249560"/>
              <a:ext cx="614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TextBox 89"/>
            <p:cNvSpPr/>
            <p:nvPr/>
          </p:nvSpPr>
          <p:spPr>
            <a:xfrm>
              <a:off x="8265240" y="1249560"/>
              <a:ext cx="614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Box 90"/>
            <p:cNvSpPr/>
            <p:nvPr/>
          </p:nvSpPr>
          <p:spPr>
            <a:xfrm>
              <a:off x="8687880" y="1249560"/>
              <a:ext cx="614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Box 91"/>
            <p:cNvSpPr/>
            <p:nvPr/>
          </p:nvSpPr>
          <p:spPr>
            <a:xfrm>
              <a:off x="9515520" y="1249560"/>
              <a:ext cx="614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Box 92"/>
            <p:cNvSpPr/>
            <p:nvPr/>
          </p:nvSpPr>
          <p:spPr>
            <a:xfrm>
              <a:off x="9896400" y="1249560"/>
              <a:ext cx="614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Box 93"/>
            <p:cNvSpPr/>
            <p:nvPr/>
          </p:nvSpPr>
          <p:spPr>
            <a:xfrm>
              <a:off x="10319040" y="1249560"/>
              <a:ext cx="6141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Box 95"/>
            <p:cNvSpPr/>
            <p:nvPr/>
          </p:nvSpPr>
          <p:spPr>
            <a:xfrm>
              <a:off x="5928120" y="2895120"/>
              <a:ext cx="19695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Arial"/>
                </a:rPr>
                <a:t>Vinculin </a:t>
              </a:r>
              <a:r>
                <a:rPr b="1" lang="en-GB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►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Box 96"/>
            <p:cNvSpPr/>
            <p:nvPr/>
          </p:nvSpPr>
          <p:spPr>
            <a:xfrm>
              <a:off x="5926680" y="1655280"/>
              <a:ext cx="19695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Arial"/>
                </a:rPr>
                <a:t>p-Akt</a:t>
              </a:r>
              <a:r>
                <a:rPr b="1" lang="en-GB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►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55" name="Picture 97" descr="Screen Clipping"/>
            <p:cNvPicPr/>
            <p:nvPr/>
          </p:nvPicPr>
          <p:blipFill>
            <a:blip r:embed="rId18"/>
            <a:srcRect l="18676" t="35119" r="22956" b="7597"/>
            <a:stretch/>
          </p:blipFill>
          <p:spPr>
            <a:xfrm>
              <a:off x="7781040" y="2341440"/>
              <a:ext cx="3254400" cy="5162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56" name="TextBox 98"/>
            <p:cNvSpPr/>
            <p:nvPr/>
          </p:nvSpPr>
          <p:spPr>
            <a:xfrm>
              <a:off x="5919840" y="2235600"/>
              <a:ext cx="19695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Arial"/>
                </a:rPr>
                <a:t>Akt</a:t>
              </a:r>
              <a:r>
                <a:rPr b="1" lang="en-GB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►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7" name="Group 12"/>
            <p:cNvGrpSpPr/>
            <p:nvPr/>
          </p:nvGrpSpPr>
          <p:grpSpPr>
            <a:xfrm>
              <a:off x="9170640" y="644400"/>
              <a:ext cx="2221200" cy="389520"/>
              <a:chOff x="9170640" y="644400"/>
              <a:chExt cx="2221200" cy="389520"/>
            </a:xfrm>
          </p:grpSpPr>
          <p:sp>
            <p:nvSpPr>
              <p:cNvPr id="158" name="Line 132"/>
              <p:cNvSpPr/>
              <p:nvPr/>
            </p:nvSpPr>
            <p:spPr>
              <a:xfrm flipV="1">
                <a:off x="9672120" y="1023120"/>
                <a:ext cx="1217880" cy="108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CustomShape 133"/>
              <p:cNvSpPr/>
              <p:nvPr/>
            </p:nvSpPr>
            <p:spPr>
              <a:xfrm>
                <a:off x="9170640" y="644400"/>
                <a:ext cx="2221200" cy="338760"/>
              </a:xfrm>
              <a:prstGeom prst="pie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2000" spc="-1" strike="noStrike">
                    <a:solidFill>
                      <a:srgbClr val="000000"/>
                    </a:solidFill>
                    <a:latin typeface="Arial"/>
                  </a:rPr>
                  <a:t>siTOPK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0" name="Group 103"/>
            <p:cNvGrpSpPr/>
            <p:nvPr/>
          </p:nvGrpSpPr>
          <p:grpSpPr>
            <a:xfrm>
              <a:off x="7422480" y="644400"/>
              <a:ext cx="2221200" cy="389520"/>
              <a:chOff x="7422480" y="644400"/>
              <a:chExt cx="2221200" cy="389520"/>
            </a:xfrm>
          </p:grpSpPr>
          <p:sp>
            <p:nvSpPr>
              <p:cNvPr id="161" name="Line 132"/>
              <p:cNvSpPr/>
              <p:nvPr/>
            </p:nvSpPr>
            <p:spPr>
              <a:xfrm flipV="1">
                <a:off x="7923960" y="1023120"/>
                <a:ext cx="1217880" cy="108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CustomShape 133"/>
              <p:cNvSpPr/>
              <p:nvPr/>
            </p:nvSpPr>
            <p:spPr>
              <a:xfrm>
                <a:off x="7422480" y="644400"/>
                <a:ext cx="2221200" cy="338760"/>
              </a:xfrm>
              <a:prstGeom prst="pie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2000" spc="-1" strike="noStrike">
                    <a:solidFill>
                      <a:srgbClr val="000000"/>
                    </a:solidFill>
                    <a:latin typeface="Arial"/>
                  </a:rPr>
                  <a:t>siNT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63" name="CustomShape 2"/>
          <p:cNvSpPr/>
          <p:nvPr/>
        </p:nvSpPr>
        <p:spPr>
          <a:xfrm>
            <a:off x="3913200" y="3798720"/>
            <a:ext cx="430200" cy="66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CustomShape 2"/>
          <p:cNvSpPr/>
          <p:nvPr/>
        </p:nvSpPr>
        <p:spPr>
          <a:xfrm>
            <a:off x="7896240" y="3798720"/>
            <a:ext cx="430200" cy="66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4760" rIns="104760" tIns="52560" bIns="5256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400" spc="-1" strike="noStrike">
                <a:solidFill>
                  <a:srgbClr val="000000"/>
                </a:solidFill>
                <a:latin typeface="Calibri"/>
              </a:rPr>
              <a:t>F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11</TotalTime>
  <Application>LibreOffice/7.4.7.2$Linux_X86_64 LibreOffice_project/40$Build-2</Application>
  <AppVersion>15.0000</AppVersion>
  <Company>University of Oxford</Company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1-01T10:16:37Z</dcterms:created>
  <dc:creator>Giacomo</dc:creator>
  <dc:description/>
  <dc:language>en-US</dc:language>
  <cp:lastModifiedBy>shanmugam.s</cp:lastModifiedBy>
  <cp:lastPrinted>2016-12-07T10:49:00Z</cp:lastPrinted>
  <dcterms:modified xsi:type="dcterms:W3CDTF">2017-06-28T16:30:49Z</dcterms:modified>
  <cp:revision>26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HiddenSlides">
    <vt:r8>0</vt:r8>
  </property>
  <property fmtid="{D5CDD505-2E9C-101B-9397-08002B2CF9AE}" pid="3" name="HyperlinksChanged">
    <vt:bool>0</vt:bool>
  </property>
  <property fmtid="{D5CDD505-2E9C-101B-9397-08002B2CF9AE}" pid="4" name="LinksUpToDate">
    <vt:bool>0</vt:bool>
  </property>
  <property fmtid="{D5CDD505-2E9C-101B-9397-08002B2CF9AE}" pid="5" name="MMClips">
    <vt:r8>0</vt:r8>
  </property>
  <property fmtid="{D5CDD505-2E9C-101B-9397-08002B2CF9AE}" pid="6" name="Notes">
    <vt:r8>0</vt:r8>
  </property>
  <property fmtid="{D5CDD505-2E9C-101B-9397-08002B2CF9AE}" pid="7" name="PresentationFormat">
    <vt:lpwstr>Custom</vt:lpwstr>
  </property>
  <property fmtid="{D5CDD505-2E9C-101B-9397-08002B2CF9AE}" pid="8" name="ScaleCrop">
    <vt:bool>0</vt:bool>
  </property>
  <property fmtid="{D5CDD505-2E9C-101B-9397-08002B2CF9AE}" pid="9" name="ShareDoc">
    <vt:bool>0</vt:bool>
  </property>
  <property fmtid="{D5CDD505-2E9C-101B-9397-08002B2CF9AE}" pid="10" name="Slides">
    <vt:r8>13</vt:r8>
  </property>
</Properties>
</file>